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B3AF65-71A1-4D5A-B0CF-21B1D8F1221D}" v="4" dt="2023-07-19T09:46:26.348"/>
    <p1510:client id="{E7E05BF1-38D5-4E57-B818-1AB9576200BB}" v="6" dt="2023-07-19T09:40:57.4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30" autoAdjust="0"/>
    <p:restoredTop sz="94660"/>
  </p:normalViewPr>
  <p:slideViewPr>
    <p:cSldViewPr snapToGrid="0">
      <p:cViewPr varScale="1">
        <p:scale>
          <a:sx n="62" d="100"/>
          <a:sy n="62" d="100"/>
        </p:scale>
        <p:origin x="84" y="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E7E05BF1-38D5-4E57-B818-1AB9576200BB}"/>
    <pc:docChg chg="custSel modSld">
      <pc:chgData name="JUAN MANUEL LOZANO GIL" userId="618ed11e-cb2c-4b03-8ac9-a8cf52f924c9" providerId="ADAL" clId="{E7E05BF1-38D5-4E57-B818-1AB9576200BB}" dt="2023-07-19T09:41:00.286" v="35" actId="1076"/>
      <pc:docMkLst>
        <pc:docMk/>
      </pc:docMkLst>
      <pc:sldChg chg="addSp delSp modSp mod">
        <pc:chgData name="JUAN MANUEL LOZANO GIL" userId="618ed11e-cb2c-4b03-8ac9-a8cf52f924c9" providerId="ADAL" clId="{E7E05BF1-38D5-4E57-B818-1AB9576200BB}" dt="2023-07-19T09:40:57.468" v="34"/>
        <pc:sldMkLst>
          <pc:docMk/>
          <pc:sldMk cId="1035658693" sldId="256"/>
        </pc:sldMkLst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2" creationId="{1939D736-7B23-B24B-A9CB-6AE0BA74F115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" creationId="{C76165A1-06C8-2493-BF25-E36E8EB5C76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4" creationId="{C5CD048B-3C4C-594F-05CC-DFFE8F336922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5" creationId="{BFFF4E04-BEEC-4AAE-E06A-FCF057697575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6" creationId="{DB3C93A7-6B1F-A143-35AC-B4F66D7FE45B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8" creationId="{1158F320-94D5-F816-48EF-ED5646B2B92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29" creationId="{2F89600A-E345-7168-3725-D0CB5F679CA7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0" creationId="{CF2E5718-F873-7701-79BA-DC346D30C4D7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1" creationId="{280CD9EE-D429-E89B-439C-C3EA9C3A4900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2" creationId="{6DFC5A4D-0299-F727-DCE5-22A21CBD1E63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3" creationId="{E4EFA5E8-3477-2F24-9110-7460580DF65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5" creationId="{C162F2C1-B9C8-6F10-D2E8-CE81B00194F2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6" creationId="{1CF5EBE3-4112-F9EE-B45C-238C3EE0511E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9" creationId="{448DBE52-4A4C-CEE5-AF91-6A25CF6641BC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40" creationId="{7888E4D4-A300-5AC7-34DB-F46F2EF57919}"/>
          </ac:spMkLst>
        </pc:spChg>
        <pc:grpChg chg="del">
          <ac:chgData name="JUAN MANUEL LOZANO GIL" userId="618ed11e-cb2c-4b03-8ac9-a8cf52f924c9" providerId="ADAL" clId="{E7E05BF1-38D5-4E57-B818-1AB9576200BB}" dt="2023-07-19T09:37:59.190" v="1" actId="478"/>
          <ac:grpSpMkLst>
            <pc:docMk/>
            <pc:sldMk cId="1035658693" sldId="256"/>
            <ac:grpSpMk id="28" creationId="{FDB1CC8B-16EF-CD3C-70E4-D811D6D67D15}"/>
          </ac:grpSpMkLst>
        </pc:grpChg>
        <pc:picChg chg="del">
          <ac:chgData name="JUAN MANUEL LOZANO GIL" userId="618ed11e-cb2c-4b03-8ac9-a8cf52f924c9" providerId="ADAL" clId="{E7E05BF1-38D5-4E57-B818-1AB9576200BB}" dt="2023-07-19T09:37:59.190" v="1" actId="478"/>
          <ac:picMkLst>
            <pc:docMk/>
            <pc:sldMk cId="1035658693" sldId="256"/>
            <ac:picMk id="7" creationId="{69940750-B75B-B98F-BF39-EBC60BB5F165}"/>
          </ac:picMkLst>
        </pc:picChg>
        <pc:picChg chg="add mod">
          <ac:chgData name="JUAN MANUEL LOZANO GIL" userId="618ed11e-cb2c-4b03-8ac9-a8cf52f924c9" providerId="ADAL" clId="{E7E05BF1-38D5-4E57-B818-1AB9576200BB}" dt="2023-07-19T09:40:57.468" v="34"/>
          <ac:picMkLst>
            <pc:docMk/>
            <pc:sldMk cId="1035658693" sldId="256"/>
            <ac:picMk id="37" creationId="{9DF0B5F6-565D-DAD4-D365-C002A3626550}"/>
          </ac:picMkLst>
        </pc:picChg>
        <pc:picChg chg="add mod">
          <ac:chgData name="JUAN MANUEL LOZANO GIL" userId="618ed11e-cb2c-4b03-8ac9-a8cf52f924c9" providerId="ADAL" clId="{E7E05BF1-38D5-4E57-B818-1AB9576200BB}" dt="2023-07-19T09:40:57.468" v="34"/>
          <ac:picMkLst>
            <pc:docMk/>
            <pc:sldMk cId="1035658693" sldId="256"/>
            <ac:picMk id="38" creationId="{93334AFA-5189-EC8C-805D-EA5ED03F966F}"/>
          </ac:picMkLst>
        </pc:picChg>
        <pc:cxnChg chg="del">
          <ac:chgData name="JUAN MANUEL LOZANO GIL" userId="618ed11e-cb2c-4b03-8ac9-a8cf52f924c9" providerId="ADAL" clId="{E7E05BF1-38D5-4E57-B818-1AB9576200BB}" dt="2023-07-19T09:37:59.190" v="1" actId="478"/>
          <ac:cxnSpMkLst>
            <pc:docMk/>
            <pc:sldMk cId="1035658693" sldId="256"/>
            <ac:cxnSpMk id="34" creationId="{9326A1D1-4DEE-52B7-1903-15FA92D9C514}"/>
          </ac:cxnSpMkLst>
        </pc:cxnChg>
      </pc:sldChg>
      <pc:sldChg chg="addSp delSp modSp mod">
        <pc:chgData name="JUAN MANUEL LOZANO GIL" userId="618ed11e-cb2c-4b03-8ac9-a8cf52f924c9" providerId="ADAL" clId="{E7E05BF1-38D5-4E57-B818-1AB9576200BB}" dt="2023-07-19T09:41:00.286" v="35" actId="1076"/>
        <pc:sldMkLst>
          <pc:docMk/>
          <pc:sldMk cId="236126241" sldId="257"/>
        </pc:sldMkLst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" creationId="{0831C752-B74D-DD76-DCF0-1E861543FC56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3" creationId="{3CDFC918-7AE1-C2AA-4300-99C5578EAF30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4" creationId="{D5B27DDA-5548-05C5-66AC-757DAA0C0984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5" creationId="{87C49FDA-52E6-E1DA-2C33-10750058E3C7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6" creationId="{296DDEC2-20F2-6B70-9DEC-937F1D7941BD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17" creationId="{34EB2C8B-EC04-2DBE-FACF-E80158B829A4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18" creationId="{237D89B5-F3D4-3D20-5541-AFCCB4CF9286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3" creationId="{73ECEC19-5292-AD15-995F-507FCA0182D1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5" creationId="{6AB2FBA6-19E3-9300-A18E-3C93CD56466A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29" creationId="{2135E244-1F3B-7BF0-3F61-E9745CC66162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0" creationId="{E74161A8-0EA0-0E29-6DB3-12E4B8BA11B5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1" creationId="{84D3EA54-4A00-DE9C-7E19-0C088717B835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2" creationId="{935DF1CE-9C86-BAEA-FCBC-116924EE940B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36" creationId="{85E60A6F-5B41-54B1-3D69-864E0DFC081C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7" creationId="{F974BC5D-743E-3E54-CAE0-CA1547C736D8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8" creationId="{A013ADB4-C966-7846-3EFC-11B6178E19EB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9" creationId="{2C02B537-9237-4438-C870-36D129F310E2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0" creationId="{1C4BC4A6-C40C-1FE4-6D81-4D36D92A5997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1" creationId="{92EB3AC3-41A6-2C5D-699F-F0471D7E0A25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2" creationId="{DF8B1217-1D65-9DB6-BEC0-F36D3626124A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3" creationId="{61185E22-0CFC-FBA4-485D-02C844505AB9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4" creationId="{DCA67F13-8C91-2942-D9F9-9B7AED3259C3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5" creationId="{80CB0E96-2351-D6FC-DA95-E11278605460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8" creationId="{8C7DDA61-85DF-C486-1884-005F9B010C0A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49" creationId="{17604D44-3EAD-254B-365E-1E46E50C392E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50" creationId="{7C6B68A9-9C88-3251-73B5-02C16B703439}"/>
          </ac:spMkLst>
        </pc:spChg>
        <pc:grpChg chg="del">
          <ac:chgData name="JUAN MANUEL LOZANO GIL" userId="618ed11e-cb2c-4b03-8ac9-a8cf52f924c9" providerId="ADAL" clId="{E7E05BF1-38D5-4E57-B818-1AB9576200BB}" dt="2023-07-19T09:37:56.999" v="0" actId="478"/>
          <ac:grpSpMkLst>
            <pc:docMk/>
            <pc:sldMk cId="236126241" sldId="257"/>
            <ac:grpSpMk id="8" creationId="{6ECEC6D2-B89B-EC32-D2E5-16233731C6B3}"/>
          </ac:grpSpMkLst>
        </pc:grpChg>
        <pc:picChg chg="del">
          <ac:chgData name="JUAN MANUEL LOZANO GIL" userId="618ed11e-cb2c-4b03-8ac9-a8cf52f924c9" providerId="ADAL" clId="{E7E05BF1-38D5-4E57-B818-1AB9576200BB}" dt="2023-07-19T09:37:56.999" v="0" actId="478"/>
          <ac:picMkLst>
            <pc:docMk/>
            <pc:sldMk cId="236126241" sldId="257"/>
            <ac:picMk id="7" creationId="{249F3737-2ECA-678D-A59E-494C5B48DC52}"/>
          </ac:picMkLst>
        </pc:picChg>
        <pc:picChg chg="add mod">
          <ac:chgData name="JUAN MANUEL LOZANO GIL" userId="618ed11e-cb2c-4b03-8ac9-a8cf52f924c9" providerId="ADAL" clId="{E7E05BF1-38D5-4E57-B818-1AB9576200BB}" dt="2023-07-19T09:41:00.286" v="35" actId="1076"/>
          <ac:picMkLst>
            <pc:docMk/>
            <pc:sldMk cId="236126241" sldId="257"/>
            <ac:picMk id="28" creationId="{244D572C-BDE0-FA5F-FFE6-CC89FE68798B}"/>
          </ac:picMkLst>
        </pc:picChg>
        <pc:picChg chg="add mod">
          <ac:chgData name="JUAN MANUEL LOZANO GIL" userId="618ed11e-cb2c-4b03-8ac9-a8cf52f924c9" providerId="ADAL" clId="{E7E05BF1-38D5-4E57-B818-1AB9576200BB}" dt="2023-07-19T09:41:00.286" v="35" actId="1076"/>
          <ac:picMkLst>
            <pc:docMk/>
            <pc:sldMk cId="236126241" sldId="257"/>
            <ac:picMk id="34" creationId="{2414A3BD-49B9-F6CC-8EDD-AA7913B25C41}"/>
          </ac:picMkLst>
        </pc:picChg>
        <pc:picChg chg="add del mod">
          <ac:chgData name="JUAN MANUEL LOZANO GIL" userId="618ed11e-cb2c-4b03-8ac9-a8cf52f924c9" providerId="ADAL" clId="{E7E05BF1-38D5-4E57-B818-1AB9576200BB}" dt="2023-07-19T09:40:56.520" v="33" actId="21"/>
          <ac:picMkLst>
            <pc:docMk/>
            <pc:sldMk cId="236126241" sldId="257"/>
            <ac:picMk id="46" creationId="{113CAFED-B7AE-BE91-3C4C-5A5D978A66DA}"/>
          </ac:picMkLst>
        </pc:picChg>
        <pc:picChg chg="add del mod">
          <ac:chgData name="JUAN MANUEL LOZANO GIL" userId="618ed11e-cb2c-4b03-8ac9-a8cf52f924c9" providerId="ADAL" clId="{E7E05BF1-38D5-4E57-B818-1AB9576200BB}" dt="2023-07-19T09:40:56.520" v="33" actId="21"/>
          <ac:picMkLst>
            <pc:docMk/>
            <pc:sldMk cId="236126241" sldId="257"/>
            <ac:picMk id="47" creationId="{83CC734D-B3E6-EC4A-577A-918E481F67BB}"/>
          </ac:picMkLst>
        </pc:picChg>
        <pc:cxnChg chg="del">
          <ac:chgData name="JUAN MANUEL LOZANO GIL" userId="618ed11e-cb2c-4b03-8ac9-a8cf52f924c9" providerId="ADAL" clId="{E7E05BF1-38D5-4E57-B818-1AB9576200BB}" dt="2023-07-19T09:37:56.999" v="0" actId="478"/>
          <ac:cxnSpMkLst>
            <pc:docMk/>
            <pc:sldMk cId="236126241" sldId="257"/>
            <ac:cxnSpMk id="33" creationId="{6AB4F24E-2418-3177-99FE-E328E98D14F3}"/>
          </ac:cxnSpMkLst>
        </pc:cxnChg>
      </pc:sldChg>
    </pc:docChg>
  </pc:docChgLst>
  <pc:docChgLst>
    <pc:chgData name="JUAN MANUEL LOZANO GIL" userId="618ed11e-cb2c-4b03-8ac9-a8cf52f924c9" providerId="ADAL" clId="{33B3AF65-71A1-4D5A-B0CF-21B1D8F1221D}"/>
    <pc:docChg chg="undo custSel modSld">
      <pc:chgData name="JUAN MANUEL LOZANO GIL" userId="618ed11e-cb2c-4b03-8ac9-a8cf52f924c9" providerId="ADAL" clId="{33B3AF65-71A1-4D5A-B0CF-21B1D8F1221D}" dt="2023-07-19T09:46:50.141" v="81" actId="20577"/>
      <pc:docMkLst>
        <pc:docMk/>
      </pc:docMkLst>
      <pc:sldChg chg="addSp delSp modSp mod">
        <pc:chgData name="JUAN MANUEL LOZANO GIL" userId="618ed11e-cb2c-4b03-8ac9-a8cf52f924c9" providerId="ADAL" clId="{33B3AF65-71A1-4D5A-B0CF-21B1D8F1221D}" dt="2023-07-19T09:46:48.221" v="80" actId="20577"/>
        <pc:sldMkLst>
          <pc:docMk/>
          <pc:sldMk cId="1035658693" sldId="256"/>
        </pc:sldMkLst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2" creationId="{1939D736-7B23-B24B-A9CB-6AE0BA74F115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3" creationId="{C76165A1-06C8-2493-BF25-E36E8EB5C761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4" creationId="{C5CD048B-3C4C-594F-05CC-DFFE8F336922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5" creationId="{BFFF4E04-BEEC-4AAE-E06A-FCF057697575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6" creationId="{DB3C93A7-6B1F-A143-35AC-B4F66D7FE45B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7" creationId="{8C2CD8C8-1627-A846-B0A6-6DF7D12BB43E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8" creationId="{1158F320-94D5-F816-48EF-ED5646B2B921}"/>
          </ac:spMkLst>
        </pc:spChg>
        <pc:spChg chg="add mod">
          <ac:chgData name="JUAN MANUEL LOZANO GIL" userId="618ed11e-cb2c-4b03-8ac9-a8cf52f924c9" providerId="ADAL" clId="{33B3AF65-71A1-4D5A-B0CF-21B1D8F1221D}" dt="2023-07-19T09:46:48.221" v="80" actId="20577"/>
          <ac:spMkLst>
            <pc:docMk/>
            <pc:sldMk cId="1035658693" sldId="256"/>
            <ac:spMk id="9" creationId="{EA575DFC-E1C2-3605-AB8E-56DD2A14EA1F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0" creationId="{FAEB9627-D1E7-DE40-7FC6-6CF5F04B10C0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1" creationId="{4E294462-FCEA-D9EF-7F57-76A142C8BE05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2" creationId="{0B24FEFC-91FE-ED57-2F4F-8BC875D7BE8F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3" creationId="{74114292-7D52-D0E9-1F54-29DA22DA360D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4" creationId="{FA539C30-2431-3C0E-CFC8-315E7C921F98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5" creationId="{2B5F4786-1F41-9DFE-CC7F-A25FEDD94440}"/>
          </ac:spMkLst>
        </pc:spChg>
        <pc:spChg chg="add mod">
          <ac:chgData name="JUAN MANUEL LOZANO GIL" userId="618ed11e-cb2c-4b03-8ac9-a8cf52f924c9" providerId="ADAL" clId="{33B3AF65-71A1-4D5A-B0CF-21B1D8F1221D}" dt="2023-07-19T09:46:27.693" v="69" actId="1076"/>
          <ac:spMkLst>
            <pc:docMk/>
            <pc:sldMk cId="1035658693" sldId="256"/>
            <ac:spMk id="16" creationId="{5BCEFC51-2884-CFDF-B05D-8C2687F26144}"/>
          </ac:spMkLst>
        </pc:spChg>
        <pc:spChg chg="add del mod">
          <ac:chgData name="JUAN MANUEL LOZANO GIL" userId="618ed11e-cb2c-4b03-8ac9-a8cf52f924c9" providerId="ADAL" clId="{33B3AF65-71A1-4D5A-B0CF-21B1D8F1221D}" dt="2023-07-19T09:46:30.140" v="71" actId="478"/>
          <ac:spMkLst>
            <pc:docMk/>
            <pc:sldMk cId="1035658693" sldId="256"/>
            <ac:spMk id="17" creationId="{6458EB09-1752-0353-5EE7-1D0E6BACA6DB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29" creationId="{2F89600A-E345-7168-3725-D0CB5F679CA7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35" creationId="{C162F2C1-B9C8-6F10-D2E8-CE81B00194F2}"/>
          </ac:spMkLst>
        </pc:spChg>
        <pc:spChg chg="del">
          <ac:chgData name="JUAN MANUEL LOZANO GIL" userId="618ed11e-cb2c-4b03-8ac9-a8cf52f924c9" providerId="ADAL" clId="{33B3AF65-71A1-4D5A-B0CF-21B1D8F1221D}" dt="2023-07-19T09:45:04.596" v="37" actId="478"/>
          <ac:spMkLst>
            <pc:docMk/>
            <pc:sldMk cId="1035658693" sldId="256"/>
            <ac:spMk id="36" creationId="{1CF5EBE3-4112-F9EE-B45C-238C3EE0511E}"/>
          </ac:spMkLst>
        </pc:spChg>
        <pc:spChg chg="mod">
          <ac:chgData name="JUAN MANUEL LOZANO GIL" userId="618ed11e-cb2c-4b03-8ac9-a8cf52f924c9" providerId="ADAL" clId="{33B3AF65-71A1-4D5A-B0CF-21B1D8F1221D}" dt="2023-07-19T09:46:29.172" v="70" actId="1076"/>
          <ac:spMkLst>
            <pc:docMk/>
            <pc:sldMk cId="1035658693" sldId="256"/>
            <ac:spMk id="39" creationId="{448DBE52-4A4C-CEE5-AF91-6A25CF6641BC}"/>
          </ac:spMkLst>
        </pc:spChg>
        <pc:spChg chg="mod ord">
          <ac:chgData name="JUAN MANUEL LOZANO GIL" userId="618ed11e-cb2c-4b03-8ac9-a8cf52f924c9" providerId="ADAL" clId="{33B3AF65-71A1-4D5A-B0CF-21B1D8F1221D}" dt="2023-07-19T09:46:36.972" v="73" actId="1076"/>
          <ac:spMkLst>
            <pc:docMk/>
            <pc:sldMk cId="1035658693" sldId="256"/>
            <ac:spMk id="40" creationId="{7888E4D4-A300-5AC7-34DB-F46F2EF57919}"/>
          </ac:spMkLst>
        </pc:spChg>
        <pc:picChg chg="add mod">
          <ac:chgData name="JUAN MANUEL LOZANO GIL" userId="618ed11e-cb2c-4b03-8ac9-a8cf52f924c9" providerId="ADAL" clId="{33B3AF65-71A1-4D5A-B0CF-21B1D8F1221D}" dt="2023-07-19T09:46:40.948" v="74" actId="208"/>
          <ac:picMkLst>
            <pc:docMk/>
            <pc:sldMk cId="1035658693" sldId="256"/>
            <ac:picMk id="18" creationId="{67F630C9-C827-5BDC-0954-BD05F39C263E}"/>
          </ac:picMkLst>
        </pc:picChg>
        <pc:picChg chg="add mod">
          <ac:chgData name="JUAN MANUEL LOZANO GIL" userId="618ed11e-cb2c-4b03-8ac9-a8cf52f924c9" providerId="ADAL" clId="{33B3AF65-71A1-4D5A-B0CF-21B1D8F1221D}" dt="2023-07-19T09:46:43.429" v="79" actId="1037"/>
          <ac:picMkLst>
            <pc:docMk/>
            <pc:sldMk cId="1035658693" sldId="256"/>
            <ac:picMk id="19" creationId="{FBFEE499-6294-CD69-C85E-E445C9F60D25}"/>
          </ac:picMkLst>
        </pc:picChg>
        <pc:picChg chg="del">
          <ac:chgData name="JUAN MANUEL LOZANO GIL" userId="618ed11e-cb2c-4b03-8ac9-a8cf52f924c9" providerId="ADAL" clId="{33B3AF65-71A1-4D5A-B0CF-21B1D8F1221D}" dt="2023-07-19T09:45:04.596" v="37" actId="478"/>
          <ac:picMkLst>
            <pc:docMk/>
            <pc:sldMk cId="1035658693" sldId="256"/>
            <ac:picMk id="37" creationId="{9DF0B5F6-565D-DAD4-D365-C002A3626550}"/>
          </ac:picMkLst>
        </pc:picChg>
        <pc:picChg chg="del">
          <ac:chgData name="JUAN MANUEL LOZANO GIL" userId="618ed11e-cb2c-4b03-8ac9-a8cf52f924c9" providerId="ADAL" clId="{33B3AF65-71A1-4D5A-B0CF-21B1D8F1221D}" dt="2023-07-19T09:45:04.596" v="37" actId="478"/>
          <ac:picMkLst>
            <pc:docMk/>
            <pc:sldMk cId="1035658693" sldId="256"/>
            <ac:picMk id="38" creationId="{93334AFA-5189-EC8C-805D-EA5ED03F966F}"/>
          </ac:picMkLst>
        </pc:picChg>
      </pc:sldChg>
      <pc:sldChg chg="addSp delSp modSp mod">
        <pc:chgData name="JUAN MANUEL LOZANO GIL" userId="618ed11e-cb2c-4b03-8ac9-a8cf52f924c9" providerId="ADAL" clId="{33B3AF65-71A1-4D5A-B0CF-21B1D8F1221D}" dt="2023-07-19T09:46:50.141" v="81" actId="20577"/>
        <pc:sldMkLst>
          <pc:docMk/>
          <pc:sldMk cId="236126241" sldId="257"/>
        </pc:sldMkLst>
        <pc:spChg chg="add del">
          <ac:chgData name="JUAN MANUEL LOZANO GIL" userId="618ed11e-cb2c-4b03-8ac9-a8cf52f924c9" providerId="ADAL" clId="{33B3AF65-71A1-4D5A-B0CF-21B1D8F1221D}" dt="2023-07-19T09:43:49.508" v="4" actId="478"/>
          <ac:spMkLst>
            <pc:docMk/>
            <pc:sldMk cId="236126241" sldId="257"/>
            <ac:spMk id="2" creationId="{0831C752-B74D-DD76-DCF0-1E861543FC56}"/>
          </ac:spMkLst>
        </pc:spChg>
        <pc:spChg chg="add del mod">
          <ac:chgData name="JUAN MANUEL LOZANO GIL" userId="618ed11e-cb2c-4b03-8ac9-a8cf52f924c9" providerId="ADAL" clId="{33B3AF65-71A1-4D5A-B0CF-21B1D8F1221D}" dt="2023-07-19T09:43:53.269" v="9" actId="478"/>
          <ac:spMkLst>
            <pc:docMk/>
            <pc:sldMk cId="236126241" sldId="257"/>
            <ac:spMk id="3" creationId="{3CDFC918-7AE1-C2AA-4300-99C5578EAF30}"/>
          </ac:spMkLst>
        </pc:spChg>
        <pc:spChg chg="add del mod">
          <ac:chgData name="JUAN MANUEL LOZANO GIL" userId="618ed11e-cb2c-4b03-8ac9-a8cf52f924c9" providerId="ADAL" clId="{33B3AF65-71A1-4D5A-B0CF-21B1D8F1221D}" dt="2023-07-19T09:43:52.269" v="8" actId="478"/>
          <ac:spMkLst>
            <pc:docMk/>
            <pc:sldMk cId="236126241" sldId="257"/>
            <ac:spMk id="4" creationId="{D5B27DDA-5548-05C5-66AC-757DAA0C0984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5" creationId="{87C49FDA-52E6-E1DA-2C33-10750058E3C7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6" creationId="{296DDEC2-20F2-6B70-9DEC-937F1D7941BD}"/>
          </ac:spMkLst>
        </pc:spChg>
        <pc:spChg chg="add del mod">
          <ac:chgData name="JUAN MANUEL LOZANO GIL" userId="618ed11e-cb2c-4b03-8ac9-a8cf52f924c9" providerId="ADAL" clId="{33B3AF65-71A1-4D5A-B0CF-21B1D8F1221D}" dt="2023-07-19T09:45:47.781" v="50" actId="478"/>
          <ac:spMkLst>
            <pc:docMk/>
            <pc:sldMk cId="236126241" sldId="257"/>
            <ac:spMk id="7" creationId="{6AD27084-91D6-0650-73D0-E3386594CF0D}"/>
          </ac:spMkLst>
        </pc:spChg>
        <pc:spChg chg="add del mod">
          <ac:chgData name="JUAN MANUEL LOZANO GIL" userId="618ed11e-cb2c-4b03-8ac9-a8cf52f924c9" providerId="ADAL" clId="{33B3AF65-71A1-4D5A-B0CF-21B1D8F1221D}" dt="2023-07-19T09:45:47.781" v="50" actId="478"/>
          <ac:spMkLst>
            <pc:docMk/>
            <pc:sldMk cId="236126241" sldId="257"/>
            <ac:spMk id="8" creationId="{0539A395-9494-B47F-2574-CF4DA777A479}"/>
          </ac:spMkLst>
        </pc:spChg>
        <pc:spChg chg="add del mod">
          <ac:chgData name="JUAN MANUEL LOZANO GIL" userId="618ed11e-cb2c-4b03-8ac9-a8cf52f924c9" providerId="ADAL" clId="{33B3AF65-71A1-4D5A-B0CF-21B1D8F1221D}" dt="2023-07-19T09:45:47.781" v="50" actId="478"/>
          <ac:spMkLst>
            <pc:docMk/>
            <pc:sldMk cId="236126241" sldId="257"/>
            <ac:spMk id="9" creationId="{89EA5BDB-1026-07B0-4D84-C90611256D96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0" creationId="{CC94EDB8-EC1E-D05F-FFC5-C236A8EB2F44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1" creationId="{B5543174-BDE3-6028-B8C1-CB61DF5B6D42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2" creationId="{DB19615B-CD32-D393-3E5C-93ED014F5E6B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3" creationId="{1684DA66-12C9-D3B6-983C-44F29A6DCD7B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4" creationId="{AF8B23AC-473E-8CCC-3A10-B9F0EBE05114}"/>
          </ac:spMkLst>
        </pc:spChg>
        <pc:spChg chg="add del mod">
          <ac:chgData name="JUAN MANUEL LOZANO GIL" userId="618ed11e-cb2c-4b03-8ac9-a8cf52f924c9" providerId="ADAL" clId="{33B3AF65-71A1-4D5A-B0CF-21B1D8F1221D}" dt="2023-07-19T09:45:48.773" v="51" actId="478"/>
          <ac:spMkLst>
            <pc:docMk/>
            <pc:sldMk cId="236126241" sldId="257"/>
            <ac:spMk id="15" creationId="{239B1759-DFAC-C37B-0685-77F80F223344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17" creationId="{34EB2C8B-EC04-2DBE-FACF-E80158B829A4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18" creationId="{237D89B5-F3D4-3D20-5541-AFCCB4CF9286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21" creationId="{E0D7E81F-4B51-DB69-23F9-5CE45E2AFFEF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22" creationId="{10B4CB18-08A7-C839-C60F-324947BBC8A4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23" creationId="{73ECEC19-5292-AD15-995F-507FCA0182D1}"/>
          </ac:spMkLst>
        </pc:spChg>
        <pc:spChg chg="add mod">
          <ac:chgData name="JUAN MANUEL LOZANO GIL" userId="618ed11e-cb2c-4b03-8ac9-a8cf52f924c9" providerId="ADAL" clId="{33B3AF65-71A1-4D5A-B0CF-21B1D8F1221D}" dt="2023-07-19T09:46:50.141" v="81" actId="20577"/>
          <ac:spMkLst>
            <pc:docMk/>
            <pc:sldMk cId="236126241" sldId="257"/>
            <ac:spMk id="24" creationId="{B7123793-EECB-9A27-50C9-9EC626416735}"/>
          </ac:spMkLst>
        </pc:spChg>
        <pc:spChg chg="add del">
          <ac:chgData name="JUAN MANUEL LOZANO GIL" userId="618ed11e-cb2c-4b03-8ac9-a8cf52f924c9" providerId="ADAL" clId="{33B3AF65-71A1-4D5A-B0CF-21B1D8F1221D}" dt="2023-07-19T09:43:54.373" v="10" actId="478"/>
          <ac:spMkLst>
            <pc:docMk/>
            <pc:sldMk cId="236126241" sldId="257"/>
            <ac:spMk id="25" creationId="{6AB2FBA6-19E3-9300-A18E-3C93CD56466A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26" creationId="{3D2189EF-D430-BA2F-0804-EC7A193D1A87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27" creationId="{4231DF71-4CBA-3DE9-9877-598E3817AF3A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29" creationId="{AF8D7981-BF87-2F0A-0EC9-48AE9B4B8B82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30" creationId="{0D1E644A-B74C-6BB9-E6B9-765146B684D4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31" creationId="{71EC2EE2-0562-D188-DC4C-9248653C33A5}"/>
          </ac:spMkLst>
        </pc:spChg>
        <pc:spChg chg="add mo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32" creationId="{A82B73CD-F4A5-DBED-FDCE-9492AD497D34}"/>
          </ac:spMkLst>
        </pc:spChg>
        <pc:spChg chg="mod">
          <ac:chgData name="JUAN MANUEL LOZANO GIL" userId="618ed11e-cb2c-4b03-8ac9-a8cf52f924c9" providerId="ADAL" clId="{33B3AF65-71A1-4D5A-B0CF-21B1D8F1221D}" dt="2023-07-19T09:45:53.012" v="54" actId="1076"/>
          <ac:spMkLst>
            <pc:docMk/>
            <pc:sldMk cId="236126241" sldId="257"/>
            <ac:spMk id="36" creationId="{85E60A6F-5B41-54B1-3D69-864E0DFC081C}"/>
          </ac:spMkLst>
        </pc:spChg>
        <pc:spChg chg="add del mod ord">
          <ac:chgData name="JUAN MANUEL LOZANO GIL" userId="618ed11e-cb2c-4b03-8ac9-a8cf52f924c9" providerId="ADAL" clId="{33B3AF65-71A1-4D5A-B0CF-21B1D8F1221D}" dt="2023-07-19T09:46:03.868" v="59" actId="1076"/>
          <ac:spMkLst>
            <pc:docMk/>
            <pc:sldMk cId="236126241" sldId="257"/>
            <ac:spMk id="49" creationId="{17604D44-3EAD-254B-365E-1E46E50C392E}"/>
          </ac:spMkLst>
        </pc:spChg>
        <pc:grpChg chg="add mod">
          <ac:chgData name="JUAN MANUEL LOZANO GIL" userId="618ed11e-cb2c-4b03-8ac9-a8cf52f924c9" providerId="ADAL" clId="{33B3AF65-71A1-4D5A-B0CF-21B1D8F1221D}" dt="2023-07-19T09:46:03.868" v="59" actId="1076"/>
          <ac:grpSpMkLst>
            <pc:docMk/>
            <pc:sldMk cId="236126241" sldId="257"/>
            <ac:grpSpMk id="33" creationId="{6138D857-35A8-9633-A0A2-9AE50FE1EC8E}"/>
          </ac:grpSpMkLst>
        </pc:grpChg>
        <pc:picChg chg="add del mod">
          <ac:chgData name="JUAN MANUEL LOZANO GIL" userId="618ed11e-cb2c-4b03-8ac9-a8cf52f924c9" providerId="ADAL" clId="{33B3AF65-71A1-4D5A-B0CF-21B1D8F1221D}" dt="2023-07-19T09:45:28.644" v="46" actId="478"/>
          <ac:picMkLst>
            <pc:docMk/>
            <pc:sldMk cId="236126241" sldId="257"/>
            <ac:picMk id="16" creationId="{98C46B0A-8524-F6B4-0E3E-92B3B53B1D64}"/>
          </ac:picMkLst>
        </pc:picChg>
        <pc:picChg chg="add del mod">
          <ac:chgData name="JUAN MANUEL LOZANO GIL" userId="618ed11e-cb2c-4b03-8ac9-a8cf52f924c9" providerId="ADAL" clId="{33B3AF65-71A1-4D5A-B0CF-21B1D8F1221D}" dt="2023-07-19T09:45:28.300" v="45" actId="478"/>
          <ac:picMkLst>
            <pc:docMk/>
            <pc:sldMk cId="236126241" sldId="257"/>
            <ac:picMk id="19" creationId="{9277B111-3219-1D17-6C8A-BFB34EBA5CF0}"/>
          </ac:picMkLst>
        </pc:picChg>
        <pc:picChg chg="add del mod">
          <ac:chgData name="JUAN MANUEL LOZANO GIL" userId="618ed11e-cb2c-4b03-8ac9-a8cf52f924c9" providerId="ADAL" clId="{33B3AF65-71A1-4D5A-B0CF-21B1D8F1221D}" dt="2023-07-19T09:45:36.692" v="49" actId="478"/>
          <ac:picMkLst>
            <pc:docMk/>
            <pc:sldMk cId="236126241" sldId="257"/>
            <ac:picMk id="20" creationId="{1846FEA9-A2AC-763C-4FD5-446A424DCC59}"/>
          </ac:picMkLst>
        </pc:picChg>
        <pc:picChg chg="add del">
          <ac:chgData name="JUAN MANUEL LOZANO GIL" userId="618ed11e-cb2c-4b03-8ac9-a8cf52f924c9" providerId="ADAL" clId="{33B3AF65-71A1-4D5A-B0CF-21B1D8F1221D}" dt="2023-07-19T09:43:47.373" v="3" actId="478"/>
          <ac:picMkLst>
            <pc:docMk/>
            <pc:sldMk cId="236126241" sldId="257"/>
            <ac:picMk id="28" creationId="{244D572C-BDE0-FA5F-FFE6-CC89FE68798B}"/>
          </ac:picMkLst>
        </pc:picChg>
        <pc:picChg chg="add del">
          <ac:chgData name="JUAN MANUEL LOZANO GIL" userId="618ed11e-cb2c-4b03-8ac9-a8cf52f924c9" providerId="ADAL" clId="{33B3AF65-71A1-4D5A-B0CF-21B1D8F1221D}" dt="2023-07-19T09:43:46.917" v="2" actId="478"/>
          <ac:picMkLst>
            <pc:docMk/>
            <pc:sldMk cId="236126241" sldId="257"/>
            <ac:picMk id="34" creationId="{2414A3BD-49B9-F6CC-8EDD-AA7913B25C41}"/>
          </ac:picMkLst>
        </pc:picChg>
        <pc:picChg chg="mod">
          <ac:chgData name="JUAN MANUEL LOZANO GIL" userId="618ed11e-cb2c-4b03-8ac9-a8cf52f924c9" providerId="ADAL" clId="{33B3AF65-71A1-4D5A-B0CF-21B1D8F1221D}" dt="2023-07-19T09:46:01.021" v="58" actId="208"/>
          <ac:picMkLst>
            <pc:docMk/>
            <pc:sldMk cId="236126241" sldId="257"/>
            <ac:picMk id="35" creationId="{E2FAC2E3-4D26-0713-DEEC-C1CD05DD92F9}"/>
          </ac:picMkLst>
        </pc:picChg>
        <pc:picChg chg="mod">
          <ac:chgData name="JUAN MANUEL LOZANO GIL" userId="618ed11e-cb2c-4b03-8ac9-a8cf52f924c9" providerId="ADAL" clId="{33B3AF65-71A1-4D5A-B0CF-21B1D8F1221D}" dt="2023-07-19T09:46:08.380" v="67" actId="1037"/>
          <ac:picMkLst>
            <pc:docMk/>
            <pc:sldMk cId="236126241" sldId="257"/>
            <ac:picMk id="37" creationId="{2995842D-11E9-9434-8730-34C03BCB72D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CA4392-5E73-0108-CBBA-28691F1D59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D831818-D66A-18DB-2017-A935F42A5C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45DBFD-F2FF-7765-D9DC-4D13E0376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ACB39D-BD0B-B377-D862-7F76BD894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1EEF2C-F670-3E35-874B-7A6553439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5879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99512B-993D-96DA-AC3E-AAB7861E0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D6B8C9-1712-ED3E-73BA-1670E9A317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A1C69F-B153-4BDA-6A9F-D6B8C78A0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B9D6BE-1C66-A9CD-183A-8FFB74192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0348AB4-4AB1-23FD-AE9F-A4C54A7EC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654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F1C2DFD-FDDB-EDA9-D82E-DFE1DCCED7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E70710D-9E2C-B5B9-4701-DFBF9615A4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DB6BC3F-4028-BC1A-E8ED-D0E7BA723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975C6B-EB7F-F388-2D1E-22B65A833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3504A6-B28E-9494-9EE8-4124106C2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423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983DC9-75BD-8969-675D-03917E38D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01FAE08-B4BE-7188-9EF3-931CC5F9AE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656958-63CE-07EA-BD1D-DCC8256E8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E7EC13-1DAD-28E2-B8E6-85BF6C755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791C74-5785-8DBF-4BFE-4D689906C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8846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954263-6C6D-09E0-104C-260D25D3D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9463E93-22D9-ED0C-168D-87EAE31EB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4D53D07-A027-EFAF-135F-11DE7E2E1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21B540-D5BD-5142-05A3-4753F291F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68CAEA-DB12-BCA1-3FEB-8BAD219D0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115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FD5BF1-DD48-BCFC-C990-E5DE502A7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AB54EEE-3B55-ABE1-DC2C-B1B8DD3201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B7CFFD-CAFC-B168-7BFA-F9531324AA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6955CEB-8849-E355-8109-ACD2A4B25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55B132F-0F3A-8991-19AB-36271FC56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66419C9-7C32-2130-E201-373A83BAD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065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980DEA-689F-B910-8678-673A468EB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C7F72B2-F1D6-955C-8F76-C75A09C74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25F160-D135-6B71-4151-5D85821BE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C90321E-F145-4921-C287-FE635C7E86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311CBB5-9DA1-530E-680D-D68DF21D67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AE2CCF7-0C74-9CCD-CD7D-CE9E29E0F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E92749C-EC66-5F54-69FD-19A18A2BB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AC9F7C4-C008-5AB0-03D1-301F3CD14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1415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4F8CB4-AACB-DCBE-07E9-FBA9A2A94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54F15A6-4026-154B-C252-0FF94CA07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D216B02-FBEB-D41A-28DA-750E2B6AD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7ABF464-DCBD-ACE2-D66B-B447DE8FC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6795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FBC671B-7586-C677-B853-2C705E63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01ED5C2-142F-82C4-7FF5-41F16DAAB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23E5E6F4-AF49-C23E-14C2-699C56515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8037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59816-12EA-74F9-6BA5-4FD35CB44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5C1C8ED-6485-4D35-69D6-17E578A2A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128AE38-51BA-F1D6-B2F5-1F38A24517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29B3D1-B531-81EF-AE34-BC61D910D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715909C-B024-CDA0-C746-E68FAEDE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7E54C9-A667-1011-0551-28B57432F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4238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ABADBE-91EB-E67C-44C0-062D0A7F5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FAD65BE-9342-E1B6-7EEC-8F5C310724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D29A3AF-E859-18E6-6E6B-B611064D49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628F86-C761-29AA-ED8E-1974A9176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35DA35A-2D9C-32BF-AC0B-A29D49B04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3D0A14D-A3A9-2456-DCDF-CC7BA7FBB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002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DD870D1-4E17-32B3-0525-D3D052031F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3431573-D3DA-3DD4-6756-5B6ACD9893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D1E7DB-2951-B127-367A-97FEDC0FAD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9843E6-E161-EE41-6982-F48050A3DF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3A41A4-FBD4-91E9-9BB0-F4579A0FCC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6746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CuadroTexto 35">
            <a:extLst>
              <a:ext uri="{FF2B5EF4-FFF2-40B4-BE49-F238E27FC236}">
                <a16:creationId xmlns:a16="http://schemas.microsoft.com/office/drawing/2014/main" id="{85E60A6F-5B41-54B1-3D69-864E0DFC081C}"/>
              </a:ext>
            </a:extLst>
          </p:cNvPr>
          <p:cNvSpPr txBox="1"/>
          <p:nvPr/>
        </p:nvSpPr>
        <p:spPr>
          <a:xfrm>
            <a:off x="8540369" y="3544090"/>
            <a:ext cx="1631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_tradnl" dirty="0"/>
              <a:t>NLRP1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E0D7E81F-4B51-DB69-23F9-5CE45E2AFFEF}"/>
              </a:ext>
            </a:extLst>
          </p:cNvPr>
          <p:cNvSpPr txBox="1"/>
          <p:nvPr/>
        </p:nvSpPr>
        <p:spPr>
          <a:xfrm rot="16200000">
            <a:off x="5711119" y="1705247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NPUT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10B4CB18-08A7-C839-C60F-324947BBC8A4}"/>
              </a:ext>
            </a:extLst>
          </p:cNvPr>
          <p:cNvSpPr txBox="1"/>
          <p:nvPr/>
        </p:nvSpPr>
        <p:spPr>
          <a:xfrm rot="16200000">
            <a:off x="6100003" y="1726888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B7123793-EECB-9A27-50C9-9EC626416735}"/>
              </a:ext>
            </a:extLst>
          </p:cNvPr>
          <p:cNvSpPr txBox="1"/>
          <p:nvPr/>
        </p:nvSpPr>
        <p:spPr>
          <a:xfrm rot="16200000">
            <a:off x="6317387" y="1482653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LRRFIP1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D2189EF-D430-BA2F-0804-EC7A193D1A87}"/>
              </a:ext>
            </a:extLst>
          </p:cNvPr>
          <p:cNvSpPr txBox="1"/>
          <p:nvPr/>
        </p:nvSpPr>
        <p:spPr>
          <a:xfrm>
            <a:off x="4682261" y="2807184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82kD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4231DF71-4CBA-3DE9-9877-598E3817AF3A}"/>
              </a:ext>
            </a:extLst>
          </p:cNvPr>
          <p:cNvSpPr txBox="1"/>
          <p:nvPr/>
        </p:nvSpPr>
        <p:spPr>
          <a:xfrm>
            <a:off x="4682261" y="3159652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16kDa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AF8D7981-BF87-2F0A-0EC9-48AE9B4B8B82}"/>
              </a:ext>
            </a:extLst>
          </p:cNvPr>
          <p:cNvSpPr txBox="1"/>
          <p:nvPr/>
        </p:nvSpPr>
        <p:spPr>
          <a:xfrm>
            <a:off x="4716725" y="3483032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82kDa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0D1E644A-B74C-6BB9-E6B9-765146B684D4}"/>
              </a:ext>
            </a:extLst>
          </p:cNvPr>
          <p:cNvSpPr txBox="1"/>
          <p:nvPr/>
        </p:nvSpPr>
        <p:spPr>
          <a:xfrm>
            <a:off x="4682261" y="3855253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64kDa</a:t>
            </a:r>
            <a:endParaRPr lang="es-ES_tradnl" sz="1050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71EC2EE2-0562-D188-DC4C-9248653C33A5}"/>
              </a:ext>
            </a:extLst>
          </p:cNvPr>
          <p:cNvSpPr txBox="1"/>
          <p:nvPr/>
        </p:nvSpPr>
        <p:spPr>
          <a:xfrm>
            <a:off x="4682261" y="4172487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49kDa</a:t>
            </a:r>
            <a:endParaRPr lang="es-ES_tradnl" sz="1050" dirty="0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A82B73CD-F4A5-DBED-FDCE-9492AD497D34}"/>
              </a:ext>
            </a:extLst>
          </p:cNvPr>
          <p:cNvSpPr txBox="1"/>
          <p:nvPr/>
        </p:nvSpPr>
        <p:spPr>
          <a:xfrm>
            <a:off x="4682261" y="4523263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37kDa</a:t>
            </a:r>
            <a:endParaRPr lang="es-ES_tradnl" sz="1050" dirty="0"/>
          </a:p>
        </p:txBody>
      </p:sp>
      <p:grpSp>
        <p:nvGrpSpPr>
          <p:cNvPr id="33" name="Agrupar 13">
            <a:extLst>
              <a:ext uri="{FF2B5EF4-FFF2-40B4-BE49-F238E27FC236}">
                <a16:creationId xmlns:a16="http://schemas.microsoft.com/office/drawing/2014/main" id="{6138D857-35A8-9633-A0A2-9AE50FE1EC8E}"/>
              </a:ext>
            </a:extLst>
          </p:cNvPr>
          <p:cNvGrpSpPr/>
          <p:nvPr/>
        </p:nvGrpSpPr>
        <p:grpSpPr>
          <a:xfrm>
            <a:off x="5201009" y="2481536"/>
            <a:ext cx="2163867" cy="2758571"/>
            <a:chOff x="3288130" y="2168418"/>
            <a:chExt cx="2163867" cy="2758571"/>
          </a:xfrm>
        </p:grpSpPr>
        <p:pic>
          <p:nvPicPr>
            <p:cNvPr id="35" name="Imagen 34">
              <a:extLst>
                <a:ext uri="{FF2B5EF4-FFF2-40B4-BE49-F238E27FC236}">
                  <a16:creationId xmlns:a16="http://schemas.microsoft.com/office/drawing/2014/main" id="{E2FAC2E3-4D26-0713-DEEC-C1CD05DD92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68" t="36805" r="40105" b="12894"/>
            <a:stretch/>
          </p:blipFill>
          <p:spPr>
            <a:xfrm>
              <a:off x="3314012" y="2168418"/>
              <a:ext cx="2137985" cy="27585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Imagen 36">
              <a:extLst>
                <a:ext uri="{FF2B5EF4-FFF2-40B4-BE49-F238E27FC236}">
                  <a16:creationId xmlns:a16="http://schemas.microsoft.com/office/drawing/2014/main" id="{2995842D-11E9-9434-8730-34C03BCB72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50" t="36271" r="59850" b="15940"/>
            <a:stretch/>
          </p:blipFill>
          <p:spPr>
            <a:xfrm>
              <a:off x="3288130" y="2168418"/>
              <a:ext cx="487647" cy="25968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49" name="Rectángulo 48">
            <a:extLst>
              <a:ext uri="{FF2B5EF4-FFF2-40B4-BE49-F238E27FC236}">
                <a16:creationId xmlns:a16="http://schemas.microsoft.com/office/drawing/2014/main" id="{17604D44-3EAD-254B-365E-1E46E50C392E}"/>
              </a:ext>
            </a:extLst>
          </p:cNvPr>
          <p:cNvSpPr/>
          <p:nvPr/>
        </p:nvSpPr>
        <p:spPr>
          <a:xfrm>
            <a:off x="5704746" y="2864359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CuadroTexto 38">
            <a:extLst>
              <a:ext uri="{FF2B5EF4-FFF2-40B4-BE49-F238E27FC236}">
                <a16:creationId xmlns:a16="http://schemas.microsoft.com/office/drawing/2014/main" id="{448DBE52-4A4C-CEE5-AF91-6A25CF6641BC}"/>
              </a:ext>
            </a:extLst>
          </p:cNvPr>
          <p:cNvSpPr txBox="1"/>
          <p:nvPr/>
        </p:nvSpPr>
        <p:spPr>
          <a:xfrm>
            <a:off x="6163475" y="3397054"/>
            <a:ext cx="1631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_tradnl" dirty="0"/>
              <a:t>LRRFIP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8C2CD8C8-1627-A846-B0A6-6DF7D12BB43E}"/>
              </a:ext>
            </a:extLst>
          </p:cNvPr>
          <p:cNvSpPr txBox="1"/>
          <p:nvPr/>
        </p:nvSpPr>
        <p:spPr>
          <a:xfrm rot="16200000">
            <a:off x="3658241" y="1687420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NPUT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A575DFC-E1C2-3605-AB8E-56DD2A14EA1F}"/>
              </a:ext>
            </a:extLst>
          </p:cNvPr>
          <p:cNvSpPr txBox="1"/>
          <p:nvPr/>
        </p:nvSpPr>
        <p:spPr>
          <a:xfrm rot="16200000">
            <a:off x="4314938" y="1409299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LRRFIP1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AEB9627-D1E7-DE40-7FC6-6CF5F04B10C0}"/>
              </a:ext>
            </a:extLst>
          </p:cNvPr>
          <p:cNvSpPr txBox="1"/>
          <p:nvPr/>
        </p:nvSpPr>
        <p:spPr>
          <a:xfrm rot="16200000">
            <a:off x="4093189" y="1687420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E294462-FCEA-D9EF-7F57-76A142C8BE05}"/>
              </a:ext>
            </a:extLst>
          </p:cNvPr>
          <p:cNvSpPr txBox="1"/>
          <p:nvPr/>
        </p:nvSpPr>
        <p:spPr>
          <a:xfrm>
            <a:off x="2724140" y="276438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82kD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0B24FEFC-91FE-ED57-2F4F-8BC875D7BE8F}"/>
              </a:ext>
            </a:extLst>
          </p:cNvPr>
          <p:cNvSpPr txBox="1"/>
          <p:nvPr/>
        </p:nvSpPr>
        <p:spPr>
          <a:xfrm>
            <a:off x="2705301" y="3143138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16kD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4114292-7D52-D0E9-1F54-29DA22DA360D}"/>
              </a:ext>
            </a:extLst>
          </p:cNvPr>
          <p:cNvSpPr txBox="1"/>
          <p:nvPr/>
        </p:nvSpPr>
        <p:spPr>
          <a:xfrm>
            <a:off x="2739765" y="3478381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82kD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FA539C30-2431-3C0E-CFC8-315E7C921F98}"/>
              </a:ext>
            </a:extLst>
          </p:cNvPr>
          <p:cNvSpPr txBox="1"/>
          <p:nvPr/>
        </p:nvSpPr>
        <p:spPr>
          <a:xfrm>
            <a:off x="2722426" y="3845415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64kDa</a:t>
            </a:r>
            <a:endParaRPr lang="es-ES_tradnl" sz="105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B5F4786-1F41-9DFE-CC7F-A25FEDD94440}"/>
              </a:ext>
            </a:extLst>
          </p:cNvPr>
          <p:cNvSpPr txBox="1"/>
          <p:nvPr/>
        </p:nvSpPr>
        <p:spPr>
          <a:xfrm>
            <a:off x="2722426" y="4180658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49kDa</a:t>
            </a:r>
            <a:endParaRPr lang="es-ES_tradnl" sz="105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BCEFC51-2884-CFDF-B05D-8C2687F26144}"/>
              </a:ext>
            </a:extLst>
          </p:cNvPr>
          <p:cNvSpPr txBox="1"/>
          <p:nvPr/>
        </p:nvSpPr>
        <p:spPr>
          <a:xfrm>
            <a:off x="2732875" y="4517032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37kDa</a:t>
            </a:r>
            <a:endParaRPr lang="es-ES_tradnl" sz="1050" dirty="0"/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id="{67F630C9-C827-5BDC-0954-BD05F39C26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22" t="29214" r="47388" b="21081"/>
          <a:stretch/>
        </p:blipFill>
        <p:spPr>
          <a:xfrm>
            <a:off x="3786985" y="2274390"/>
            <a:ext cx="1462266" cy="28343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FBFEE499-6294-CD69-C85E-E445C9F60D2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6000" contrast="-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39" t="28742" r="66578" b="21080"/>
          <a:stretch/>
        </p:blipFill>
        <p:spPr>
          <a:xfrm>
            <a:off x="3367903" y="2247458"/>
            <a:ext cx="341592" cy="2861311"/>
          </a:xfrm>
          <a:prstGeom prst="rect">
            <a:avLst/>
          </a:prstGeom>
        </p:spPr>
      </p:pic>
      <p:sp>
        <p:nvSpPr>
          <p:cNvPr id="40" name="Rectángulo 39">
            <a:extLst>
              <a:ext uri="{FF2B5EF4-FFF2-40B4-BE49-F238E27FC236}">
                <a16:creationId xmlns:a16="http://schemas.microsoft.com/office/drawing/2014/main" id="{7888E4D4-A300-5AC7-34DB-F46F2EF57919}"/>
              </a:ext>
            </a:extLst>
          </p:cNvPr>
          <p:cNvSpPr/>
          <p:nvPr/>
        </p:nvSpPr>
        <p:spPr>
          <a:xfrm>
            <a:off x="3786985" y="2833639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56586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4</Words>
  <Application>Microsoft Office PowerPoint</Application>
  <PresentationFormat>Panorámica</PresentationFormat>
  <Paragraphs>20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9T09:46:57Z</dcterms:modified>
</cp:coreProperties>
</file>